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951663" cy="923766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18EE5-3A59-4AB1-94D2-9C62CE7A072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78861-E028-4663-A6F0-90C19C5DAA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F2062-9BC0-4744-BC05-E6615002CD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B56B4-65D0-4890-8AD9-AC68A4DD01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295002-9C37-4269-ADA5-18A5ECD560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4DD2B-56BF-4F4A-A07A-294449CA8A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E9F4F-A469-4608-A3F9-58512D8093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ED059-B31E-42D7-BD4A-2A3F5569DA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00FB6E-D104-4837-B4D2-C1BD4AC32A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DD8FF-8F1B-4381-ABE3-623AECE774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3B0BA6-A3A4-4036-8037-6DEE67FF7D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D9CDD-C9A3-4033-88FC-8D1E588F79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3798711-3DA5-40F4-A5A8-56FC2F913E5C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19F97A8-EA0B-4729-A9A2-C6C78722C10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99"/>
          <p:cNvGrpSpPr/>
          <p:nvPr/>
        </p:nvGrpSpPr>
        <p:grpSpPr>
          <a:xfrm>
            <a:off x="162000" y="946800"/>
            <a:ext cx="6275160" cy="4796640"/>
            <a:chOff x="162000" y="946800"/>
            <a:chExt cx="6275160" cy="4796640"/>
          </a:xfrm>
        </p:grpSpPr>
        <p:sp>
          <p:nvSpPr>
            <p:cNvPr id="42" name="Rectangle 3"/>
            <p:cNvSpPr/>
            <p:nvPr/>
          </p:nvSpPr>
          <p:spPr>
            <a:xfrm>
              <a:off x="2348640" y="948240"/>
              <a:ext cx="2160360" cy="231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1082 people were screened over phon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3" name="Straight Arrow Connector 7"/>
            <p:cNvCxnSpPr>
              <a:stCxn id="42" idx="2"/>
            </p:cNvCxnSpPr>
            <p:nvPr/>
          </p:nvCxnSpPr>
          <p:spPr>
            <a:xfrm flipH="1">
              <a:off x="3426840" y="1179360"/>
              <a:ext cx="2160" cy="19656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4" name="Rectangle 4"/>
            <p:cNvSpPr/>
            <p:nvPr/>
          </p:nvSpPr>
          <p:spPr>
            <a:xfrm>
              <a:off x="1374840" y="3928320"/>
              <a:ext cx="1549080" cy="231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8 in the intervention grou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5" name="Straight Arrow Connector 22"/>
            <p:cNvCxnSpPr/>
            <p:nvPr/>
          </p:nvCxnSpPr>
          <p:spPr>
            <a:xfrm>
              <a:off x="3858840" y="3513240"/>
              <a:ext cx="578520" cy="39600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6" name="Rectangle 4"/>
            <p:cNvSpPr/>
            <p:nvPr/>
          </p:nvSpPr>
          <p:spPr>
            <a:xfrm>
              <a:off x="3961800" y="3928320"/>
              <a:ext cx="1519200" cy="231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7 in the control grou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7" name="Straight Arrow Connector 29"/>
            <p:cNvCxnSpPr/>
            <p:nvPr/>
          </p:nvCxnSpPr>
          <p:spPr>
            <a:xfrm flipH="1">
              <a:off x="2347920" y="3524040"/>
              <a:ext cx="576360" cy="38484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48" name="Rectangle 4"/>
            <p:cNvSpPr/>
            <p:nvPr/>
          </p:nvSpPr>
          <p:spPr>
            <a:xfrm>
              <a:off x="2366280" y="424764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1 withdrew owing to family reaso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49" name="Straight Arrow Connector 37"/>
            <p:cNvCxnSpPr>
              <a:endCxn id="50" idx="0"/>
            </p:cNvCxnSpPr>
            <p:nvPr/>
          </p:nvCxnSpPr>
          <p:spPr>
            <a:xfrm>
              <a:off x="2058840" y="4160520"/>
              <a:ext cx="2160" cy="47916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1" name="Straight Arrow Connector 38"/>
            <p:cNvCxnSpPr>
              <a:endCxn id="48" idx="1"/>
            </p:cNvCxnSpPr>
            <p:nvPr/>
          </p:nvCxnSpPr>
          <p:spPr>
            <a:xfrm flipV="1">
              <a:off x="2060280" y="4431600"/>
              <a:ext cx="306360" cy="10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0" name="Rectangle 4"/>
            <p:cNvSpPr/>
            <p:nvPr/>
          </p:nvSpPr>
          <p:spPr>
            <a:xfrm>
              <a:off x="1377360" y="463932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7 completed final assessme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4"/>
            <p:cNvSpPr/>
            <p:nvPr/>
          </p:nvSpPr>
          <p:spPr>
            <a:xfrm>
              <a:off x="1374840" y="537516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8 were included in the  analysi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"/>
            <p:cNvSpPr/>
            <p:nvPr/>
          </p:nvSpPr>
          <p:spPr>
            <a:xfrm>
              <a:off x="5070600" y="424440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2 withdrew owing to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personal reaso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54" name="Straight Arrow Connector 61"/>
            <p:cNvCxnSpPr>
              <a:stCxn id="46" idx="2"/>
              <a:endCxn id="55" idx="0"/>
            </p:cNvCxnSpPr>
            <p:nvPr/>
          </p:nvCxnSpPr>
          <p:spPr>
            <a:xfrm>
              <a:off x="4721400" y="4159440"/>
              <a:ext cx="2880" cy="47988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6" name="Straight Arrow Connector 62"/>
            <p:cNvCxnSpPr>
              <a:endCxn id="53" idx="1"/>
            </p:cNvCxnSpPr>
            <p:nvPr/>
          </p:nvCxnSpPr>
          <p:spPr>
            <a:xfrm flipV="1">
              <a:off x="4723920" y="4428360"/>
              <a:ext cx="347040" cy="720"/>
            </a:xfrm>
            <a:prstGeom prst="straightConnector1">
              <a:avLst/>
            </a:prstGeom>
            <a:ln w="648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5" name="Rectangle 4"/>
            <p:cNvSpPr/>
            <p:nvPr/>
          </p:nvSpPr>
          <p:spPr>
            <a:xfrm>
              <a:off x="4040640" y="463896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5 completed final assessme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4"/>
            <p:cNvSpPr/>
            <p:nvPr/>
          </p:nvSpPr>
          <p:spPr>
            <a:xfrm>
              <a:off x="4038120" y="5375160"/>
              <a:ext cx="1366560" cy="368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37 were included in the  analysi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"/>
            <p:cNvSpPr/>
            <p:nvPr/>
          </p:nvSpPr>
          <p:spPr>
            <a:xfrm>
              <a:off x="162000" y="946800"/>
              <a:ext cx="1800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October 2016 – January 20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"/>
            <p:cNvSpPr/>
            <p:nvPr/>
          </p:nvSpPr>
          <p:spPr>
            <a:xfrm>
              <a:off x="185040" y="3131640"/>
              <a:ext cx="951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January 20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"/>
            <p:cNvSpPr/>
            <p:nvPr/>
          </p:nvSpPr>
          <p:spPr>
            <a:xfrm>
              <a:off x="259920" y="4707720"/>
              <a:ext cx="1008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108000" rIns="108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May – June 20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TextBox 97"/>
          <p:cNvSpPr/>
          <p:nvPr/>
        </p:nvSpPr>
        <p:spPr>
          <a:xfrm>
            <a:off x="400320" y="6248520"/>
            <a:ext cx="5485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l Figure 1. Enrollment of the Participants and Completion of the Study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4"/>
          <p:cNvSpPr/>
          <p:nvPr/>
        </p:nvSpPr>
        <p:spPr>
          <a:xfrm>
            <a:off x="162000" y="3791880"/>
            <a:ext cx="998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Feb - May 20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4"/>
          <p:cNvSpPr/>
          <p:nvPr/>
        </p:nvSpPr>
        <p:spPr>
          <a:xfrm>
            <a:off x="2565360" y="3154320"/>
            <a:ext cx="1871640" cy="36828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75 underwent baseline assessment and were randomize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"/>
          <p:cNvSpPr/>
          <p:nvPr/>
        </p:nvSpPr>
        <p:spPr>
          <a:xfrm>
            <a:off x="2781360" y="1375920"/>
            <a:ext cx="1366920" cy="23112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122 in-person meeting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"/>
          <p:cNvSpPr/>
          <p:nvPr/>
        </p:nvSpPr>
        <p:spPr>
          <a:xfrm>
            <a:off x="2133720" y="2221200"/>
            <a:ext cx="1725480" cy="23112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102 signed the consent for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5"/>
          <p:cNvSpPr/>
          <p:nvPr/>
        </p:nvSpPr>
        <p:spPr>
          <a:xfrm>
            <a:off x="3952800" y="1679760"/>
            <a:ext cx="2860920" cy="642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20 excluded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13 outside BMI rang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3 diagnosed with diabet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4 not willing to be in the vegan or the control grou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Straight Arrow Connector 44"/>
          <p:cNvCxnSpPr/>
          <p:nvPr/>
        </p:nvCxnSpPr>
        <p:spPr>
          <a:xfrm>
            <a:off x="3429000" y="1999800"/>
            <a:ext cx="5263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Rectangle 5"/>
          <p:cNvSpPr/>
          <p:nvPr/>
        </p:nvSpPr>
        <p:spPr>
          <a:xfrm>
            <a:off x="3954600" y="2397960"/>
            <a:ext cx="2786040" cy="642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108000" rIns="108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27 excluded: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20 did not turn in their diet record or did not come   to their baseline assessme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 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Times New Roman"/>
              </a:rPr>
              <a:t>7 withdrew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9" name="Straight Arrow Connector 47"/>
          <p:cNvCxnSpPr>
            <a:endCxn id="68" idx="1"/>
          </p:cNvCxnSpPr>
          <p:nvPr/>
        </p:nvCxnSpPr>
        <p:spPr>
          <a:xfrm>
            <a:off x="3429000" y="2719080"/>
            <a:ext cx="525960" cy="3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31T08:30:01Z</dcterms:created>
  <dc:creator>Hana Kahleová</dc:creator>
  <dc:description/>
  <dc:language>en-US</dc:language>
  <cp:lastModifiedBy>Hana Kahleova</cp:lastModifiedBy>
  <cp:lastPrinted>2017-06-07T14:20:05Z</cp:lastPrinted>
  <dcterms:modified xsi:type="dcterms:W3CDTF">2018-04-11T20:36:36Z</dcterms:modified>
  <cp:revision>77</cp:revision>
  <dc:subject/>
  <dc:title>Slide 1</dc:title>
</cp:coreProperties>
</file>